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  <p:sldId id="276" r:id="rId3"/>
    <p:sldId id="271" r:id="rId4"/>
    <p:sldId id="27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90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E1D6BF-0CB8-5F8D-A352-1836D28642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1342DEC-0A42-B035-7137-B37FB0A614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4042B2-281E-887C-E6E1-23FCCFFF73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0CFFDE-D3BB-2F45-B559-26578F903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C434A8-5664-4DE9-087D-6CE3AB0C1F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157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36B812-1154-2505-B73A-DA6E4A0BD7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E81B93-2118-A4CF-8A3B-B7A52B1187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725CEA-B303-3FB9-F483-EE52B310A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647003-9AD3-0106-1DDB-6F3265A7F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6F8B46-3DF6-5B5B-D7AE-246B4538C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4924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1B080A-4431-7A0F-3760-57810FB16A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C0D959-ADDC-1084-9EEE-D98B37EC26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27C306-7B3B-F56C-FCDA-C5A588A8B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B3D385-DE38-4FC4-7D2E-706FE6A70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036EE8-F945-80FB-6FE0-C499472B6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5465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91F9FE-2A09-1F8B-53A1-477F102426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446264-6303-7233-89FA-E9B88E54F6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D7CAB8-96A4-0A3D-870C-C9B1D3926D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73B5F8-C92C-11DB-89BB-0CC1E90DB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1596AE-1952-C8BE-CE2C-7DFD56D56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3161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4AB54E-57A7-626D-E711-CE5F6EA02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95C5A7-CCFC-7718-6D96-914134DFA7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0C2FFE-6E10-8399-C82E-68400E9C57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648877-6344-426F-5483-C15083D5F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970EEA-479C-852C-7C2F-D0BB4A2343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756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DF3F87-FC2A-20AC-65A0-EA32DDCC91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011EE7-BF22-055E-1E7D-89368B9098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C02C66-1695-2022-983A-A49DCD12F5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BF0279-1342-6483-B27E-E3AB4CBB5F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ECF091-FA80-A879-4551-DFD21AECA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E63B80-9A5B-1B4A-6A85-198A146F1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196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BCA643-962D-2159-3CD2-B8307F61F6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168017-F561-D6EC-676B-3F9076A5CF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093738-FDC8-D1B6-BBE8-0F3DE2A52F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A992896-E350-AC30-C400-E50B8DFD1C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03D35D0-6EA6-E00E-9E10-E6DC2F1037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0E11EC8-DA82-FAA5-0B91-1E8176ADE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DB4813-7781-0E34-624C-C832D2BD5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81EF7B-B94C-77BA-6889-607CE909C6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2256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C9B03B-516A-C2E4-A828-AB44074B60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7227AE-1D02-84AF-D1FD-523A55B25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46059C-E2E9-84B5-D783-D88FA36C1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9734DB-F9C0-12F8-80D6-AAD7830AA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5462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026100-3F71-A1AD-C758-5331C2336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A562FE-608C-CF4F-1958-15872B03F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8A3A5D-3BF9-422A-C499-E4D35CCA7F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5739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436AD5-0AA6-643B-4BFF-69762F68E5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16922A-009C-5113-B39A-7D9D30312C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60CDEA-6459-8DD0-3ED0-DB4B8AF87D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11737C-FD1B-EB6F-5FCC-D5B9D9705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12300A-6364-8693-4F9E-B838B33D1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571039-A2CC-476B-A6B3-9FBE80AA4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6084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EAB91-20A8-0EDB-8B19-622E57114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F6780C-3F8F-C53F-2C9A-94D5202E9B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3E8AB4-4114-C6C6-9D6B-85C1606DB9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9AA461-DCFF-8FEE-76AE-5A72AD1FE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E7AF16-73F5-3A36-C81D-1DC0C4A24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5C2655-3BBD-7DF0-0281-59D1142E1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3230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BDB48A-0FC4-5A43-A22B-BA145B7457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EA29CE-8522-1A9A-AC54-B1EF40A8D7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D7D321-40B7-B2A9-B61B-D6C638538B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11C34F-AD6D-44D4-B2C8-D2E59455378A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FB6C51-F48D-9AEC-D308-485ACAC1B2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3D113E-2E1C-8827-F2BE-475ECEDF53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6A3E8-18A6-4F26-B2F5-9E0A12A391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326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BF2543F-A1B1-FF9B-B746-FD15FE5375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2189" y="450872"/>
            <a:ext cx="5407621" cy="534665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C2F9F8D-AC82-A1DD-24CC-DF0B61298F6D}"/>
              </a:ext>
            </a:extLst>
          </p:cNvPr>
          <p:cNvSpPr txBox="1"/>
          <p:nvPr/>
        </p:nvSpPr>
        <p:spPr>
          <a:xfrm>
            <a:off x="848316" y="5881821"/>
            <a:ext cx="10881827" cy="670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A: </a:t>
            </a:r>
            <a:r>
              <a:rPr kumimoji="0" lang="en-US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blood smear showing abnormalities in red blood cells collected from dogs.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B: </a:t>
            </a:r>
            <a:r>
              <a:rPr kumimoji="0" lang="en-US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spected presence of </a:t>
            </a:r>
            <a:r>
              <a:rPr kumimoji="0" lang="en-US" sz="180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aplasma</a:t>
            </a:r>
            <a:r>
              <a:rPr kumimoji="0" lang="en-US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pp. C and D: suspected presence of </a:t>
            </a:r>
            <a:r>
              <a:rPr kumimoji="0" lang="en-US" sz="180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abesia</a:t>
            </a:r>
            <a:r>
              <a:rPr kumimoji="0" lang="en-US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sz="1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pp</a:t>
            </a:r>
            <a:endParaRPr kumimoji="0" lang="en-GB" sz="16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2429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C2F2A98-0FC2-CAF7-AF1E-7FD7AA7CEC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5622" y="734413"/>
            <a:ext cx="5300755" cy="438341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550EC2E-28B9-204F-60BA-9561616E665B}"/>
              </a:ext>
            </a:extLst>
          </p:cNvPr>
          <p:cNvSpPr txBox="1"/>
          <p:nvPr/>
        </p:nvSpPr>
        <p:spPr>
          <a:xfrm>
            <a:off x="195042" y="5773666"/>
            <a:ext cx="120491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>
                <a:latin typeface="Times New Roman" panose="02020603050405020304" pitchFamily="18" charset="0"/>
                <a:ea typeface="Yu Mincho" panose="02020400000000000000" pitchFamily="18" charset="-128"/>
              </a:rPr>
              <a:t>Supplementary Figure  2.</a:t>
            </a:r>
            <a:r>
              <a:rPr lang="en-GB" dirty="0">
                <a:latin typeface="Times New Roman" panose="02020603050405020304" pitchFamily="18" charset="0"/>
                <a:ea typeface="Yu Mincho" panose="02020400000000000000" pitchFamily="18" charset="-128"/>
              </a:rPr>
              <a:t>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Rhipicephalus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sanguineus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male dorsal surface.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Rhipicephalus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sanguineus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male ventral surface</a:t>
            </a:r>
          </a:p>
          <a:p>
            <a:pPr algn="just"/>
            <a:r>
              <a:rPr lang="en-US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Rhipicephalus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annulatus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female dorsal surface.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Rhipicephalus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annulatus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female ventral surface. Scale bar (0.50 mm)</a:t>
            </a:r>
          </a:p>
        </p:txBody>
      </p:sp>
    </p:spTree>
    <p:extLst>
      <p:ext uri="{BB962C8B-B14F-4D97-AF65-F5344CB8AC3E}">
        <p14:creationId xmlns:p14="http://schemas.microsoft.com/office/powerpoint/2010/main" val="42671080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394362" y="968860"/>
            <a:ext cx="5985165" cy="3450758"/>
            <a:chOff x="3394362" y="1024280"/>
            <a:chExt cx="5985165" cy="3450758"/>
          </a:xfrm>
        </p:grpSpPr>
        <p:pic>
          <p:nvPicPr>
            <p:cNvPr id="1026" name="Picture 2" descr="C:\Users\Md Haroon\Desktop\Ahmed\dog ticks\mtrrs for presentation.TIF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81" t="18031" r="42729" b="22272"/>
            <a:stretch/>
          </p:blipFill>
          <p:spPr bwMode="auto">
            <a:xfrm>
              <a:off x="3394362" y="1024280"/>
              <a:ext cx="5985165" cy="34507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08C619C-3F39-35CE-F329-568AD9BB8CF2}"/>
                </a:ext>
              </a:extLst>
            </p:cNvPr>
            <p:cNvSpPr txBox="1"/>
            <p:nvPr/>
          </p:nvSpPr>
          <p:spPr>
            <a:xfrm>
              <a:off x="3532912" y="1055757"/>
              <a:ext cx="584661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 M           N              </a:t>
              </a:r>
              <a:r>
                <a:rPr lang="en-GB" sz="1200" b="1" noProof="0" dirty="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2              </a:t>
              </a:r>
              <a:r>
                <a:rPr lang="en-GB" sz="1200" b="1" dirty="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</a:t>
              </a:r>
              <a:r>
                <a:rPr lang="en-GB" sz="1200" b="1" dirty="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</a:t>
              </a:r>
              <a:r>
                <a:rPr lang="en-GB" sz="1200" b="1" dirty="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</a:t>
              </a:r>
              <a:r>
                <a:rPr lang="en-GB" sz="1200" b="1" dirty="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</a:t>
              </a:r>
              <a:r>
                <a:rPr lang="en-GB" sz="1200" b="1" dirty="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</a:t>
              </a:r>
              <a:r>
                <a:rPr lang="en-GB" sz="1200" b="1" noProof="0" dirty="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202BE024-1779-CEFF-30E2-BC993C1A3356}"/>
              </a:ext>
            </a:extLst>
          </p:cNvPr>
          <p:cNvSpPr txBox="1"/>
          <p:nvPr/>
        </p:nvSpPr>
        <p:spPr>
          <a:xfrm>
            <a:off x="457200" y="4468666"/>
            <a:ext cx="1140229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</a:t>
            </a:r>
            <a:r>
              <a:rPr lang="en-GB" b="1" noProof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gure </a:t>
            </a:r>
            <a:r>
              <a:rPr kumimoji="0" lang="ar-SA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</a:t>
            </a: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.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etection of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 16S rRNA gene specific for tick species. </a:t>
            </a:r>
            <a:r>
              <a:rPr lang="en-GB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M: marker, N: negative control, and the numbers of positive samples )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C9E2827-8769-D813-451B-92A7251BBC8C}"/>
              </a:ext>
            </a:extLst>
          </p:cNvPr>
          <p:cNvSpPr txBox="1"/>
          <p:nvPr/>
        </p:nvSpPr>
        <p:spPr>
          <a:xfrm>
            <a:off x="2978782" y="1000337"/>
            <a:ext cx="527509" cy="33239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27066889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02BE024-1779-CEFF-30E2-BC993C1A3356}"/>
              </a:ext>
            </a:extLst>
          </p:cNvPr>
          <p:cNvSpPr txBox="1"/>
          <p:nvPr/>
        </p:nvSpPr>
        <p:spPr>
          <a:xfrm>
            <a:off x="388058" y="5230691"/>
            <a:ext cx="1180394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</a:t>
            </a:r>
            <a:r>
              <a:rPr lang="en-US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0" lang="en-GB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gure</a:t>
            </a: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ar-SA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4</a:t>
            </a:r>
            <a:r>
              <a:rPr kumimoji="0" lang="en-GB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A: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etection of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ajor surface protein 4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msp4) gene of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. marginale</a:t>
            </a:r>
            <a:r>
              <a:rPr kumimoji="0" lang="pt-BR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ene</a:t>
            </a:r>
            <a:r>
              <a:rPr kumimoji="0" lang="ar-EG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 DNA extracted from blood of dogs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</a:t>
            </a: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: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etection of the </a:t>
            </a:r>
            <a:r>
              <a:rPr kumimoji="0" lang="en-GB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mall subunit ribosomal RNA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SSU rRNA) gene of </a:t>
            </a:r>
            <a:r>
              <a:rPr kumimoji="0" lang="en-GB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. </a:t>
            </a:r>
            <a:r>
              <a:rPr kumimoji="0" lang="en-GB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anis</a:t>
            </a:r>
            <a:r>
              <a:rPr kumimoji="0" lang="en-GB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en-GB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vogeli</a:t>
            </a:r>
            <a:r>
              <a:rPr kumimoji="0" lang="en-GB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 DNA extracted from blood of dogs(M: marker, N: negative control, and the numbers of positive samples 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74FA7FD-BED1-BC1D-7105-6C5DCA16A0B2}"/>
              </a:ext>
            </a:extLst>
          </p:cNvPr>
          <p:cNvSpPr txBox="1"/>
          <p:nvPr/>
        </p:nvSpPr>
        <p:spPr>
          <a:xfrm>
            <a:off x="5784895" y="1511240"/>
            <a:ext cx="418467" cy="26622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ar-SA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ar-SA" sz="7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ar-SA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ar-SA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000</a:t>
            </a: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5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5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5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5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68D82D86-1B03-CAEA-387F-D1870E517A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9519" y="1637342"/>
            <a:ext cx="2830285" cy="2985796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F9FFE4C7-E83F-D4E2-E993-61C360927932}"/>
              </a:ext>
            </a:extLst>
          </p:cNvPr>
          <p:cNvSpPr/>
          <p:nvPr/>
        </p:nvSpPr>
        <p:spPr>
          <a:xfrm>
            <a:off x="2711741" y="4313504"/>
            <a:ext cx="289004" cy="31389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C9E2827-8769-D813-451B-92A7251BBC8C}"/>
              </a:ext>
            </a:extLst>
          </p:cNvPr>
          <p:cNvSpPr txBox="1"/>
          <p:nvPr/>
        </p:nvSpPr>
        <p:spPr>
          <a:xfrm>
            <a:off x="2358628" y="1633078"/>
            <a:ext cx="418467" cy="26161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ar-SA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ar-SA" sz="7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ar-SA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5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5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FA23F76-2F3D-2874-0E92-3B40BE540B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637342"/>
            <a:ext cx="2830285" cy="298579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CEEE79FE-C184-643E-18A9-627EA718849C}"/>
              </a:ext>
            </a:extLst>
          </p:cNvPr>
          <p:cNvSpPr txBox="1"/>
          <p:nvPr/>
        </p:nvSpPr>
        <p:spPr>
          <a:xfrm>
            <a:off x="6111460" y="1637342"/>
            <a:ext cx="269749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   M                N              2               5              15              42                               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626ED95-D5F3-9C25-ED6A-0ABB3AA2F61E}"/>
              </a:ext>
            </a:extLst>
          </p:cNvPr>
          <p:cNvSpPr/>
          <p:nvPr/>
        </p:nvSpPr>
        <p:spPr>
          <a:xfrm>
            <a:off x="6111460" y="4309240"/>
            <a:ext cx="289004" cy="31389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08C619C-3F39-35CE-F329-568AD9BB8CF2}"/>
              </a:ext>
            </a:extLst>
          </p:cNvPr>
          <p:cNvSpPr txBox="1"/>
          <p:nvPr/>
        </p:nvSpPr>
        <p:spPr>
          <a:xfrm>
            <a:off x="2793735" y="1596102"/>
            <a:ext cx="269749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   M                N               1                12             17             20            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3532290594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</TotalTime>
  <Words>228</Words>
  <Application>Microsoft Office PowerPoint</Application>
  <PresentationFormat>Widescreen</PresentationFormat>
  <Paragraphs>8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2_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ssan youssef</dc:creator>
  <cp:lastModifiedBy>hassan youssef</cp:lastModifiedBy>
  <cp:revision>4</cp:revision>
  <dcterms:created xsi:type="dcterms:W3CDTF">2024-05-25T15:25:58Z</dcterms:created>
  <dcterms:modified xsi:type="dcterms:W3CDTF">2024-05-29T08:58:49Z</dcterms:modified>
</cp:coreProperties>
</file>